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9" r:id="rId3"/>
    <p:sldId id="260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>
        <p:scale>
          <a:sx n="75" d="100"/>
          <a:sy n="75" d="100"/>
        </p:scale>
        <p:origin x="-312" y="22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3-06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013692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3-06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7450727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3-06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283936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3-06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753521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3-06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966272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3-06-2020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218040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3-06-2020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225196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3-06-2020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455531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3-06-2020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929438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3-06-2020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099059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DFB0-C515-4C80-B987-E5052D0E360E}" type="datetimeFigureOut">
              <a:rPr lang="en-IN" smtClean="0"/>
              <a:t>13-06-2020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779465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73DFB0-C515-4C80-B987-E5052D0E360E}" type="datetimeFigureOut">
              <a:rPr lang="en-IN" smtClean="0"/>
              <a:t>13-06-2020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B12E88-3151-4DC3-A601-3B2A2618632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317772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39634" y="151000"/>
            <a:ext cx="1185236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A  Table:</a:t>
            </a:r>
          </a:p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vel </a:t>
            </a:r>
            <a:r>
              <a:rPr lang="en-US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MD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ne mutations  identified in our cohort of 961 suspected DMD patients with LOVD submission numbers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93288300"/>
              </p:ext>
            </p:extLst>
          </p:nvPr>
        </p:nvGraphicFramePr>
        <p:xfrm>
          <a:off x="913549" y="1337812"/>
          <a:ext cx="4764439" cy="5485876"/>
        </p:xfrm>
        <a:graphic>
          <a:graphicData uri="http://schemas.openxmlformats.org/drawingml/2006/table">
            <a:tbl>
              <a:tblPr/>
              <a:tblGrid>
                <a:gridCol w="1583136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272521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954391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954391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49871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Lab ID</a:t>
                      </a:r>
                      <a:endParaRPr lang="en-US" sz="105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Exon</a:t>
                      </a:r>
                      <a:endParaRPr lang="en-US" sz="105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# of patients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Individual ID  LOVD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493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2215/DBI-1763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on 8-17 Deletion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269321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493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447/DBI-1202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on 13-19 Deletion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269327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2493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2114/DBI-1679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on 4-12 Deletion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269328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2493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46/B-44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xon 56-61 Deletion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269329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2493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2015/DBI-1612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xon 57-71 Deletion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269331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2493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2110/DBI-1678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on 12-16 Deletion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269332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2493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2118/DBI-1682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on 14-17 Deletion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269333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2493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731/DBI-640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on 18-39 Deletion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269353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2493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2079/DBI-1655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on 18-41 Deletion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269355</a:t>
                      </a:r>
                    </a:p>
                  </a:txBody>
                  <a:tcPr marL="6144" marR="6144" marT="61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2493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892/DBI-771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on 20-30 Deletion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269356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2493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159/DBI-1717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on 22-39 Deletion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269395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2493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2185//DBI-1741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on 3-12 Deletion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269358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2493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931/DBI-1550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xon 3-18 Deletion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269396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  <a:tr h="2493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114/B-126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on 35-45 Deletion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269361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4"/>
                  </a:ext>
                </a:extLst>
              </a:tr>
              <a:tr h="2493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4987/DBI-3748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xon 45-56 Deletion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269366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5"/>
                  </a:ext>
                </a:extLst>
              </a:tr>
              <a:tr h="2493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58/B-56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on 46-55 Deletion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269367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6"/>
                  </a:ext>
                </a:extLst>
              </a:tr>
              <a:tr h="2493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031/DBI-874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on 48-56 Deletion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269368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7"/>
                  </a:ext>
                </a:extLst>
              </a:tr>
              <a:tr h="2493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958/DBI-1572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on 54-79 Deletion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269371</a:t>
                      </a:r>
                    </a:p>
                  </a:txBody>
                  <a:tcPr marL="6144" marR="6144" marT="61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18"/>
                  </a:ext>
                </a:extLst>
              </a:tr>
              <a:tr h="2493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2067/DBI-1649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on 8-15 Deletion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269372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9"/>
                  </a:ext>
                </a:extLst>
              </a:tr>
              <a:tr h="2493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647/DBI-1352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on 8-16 Deletion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2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269373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0"/>
                  </a:ext>
                </a:extLst>
              </a:tr>
            </a:tbl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5025723" y="968480"/>
            <a:ext cx="19611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0 Novel deletions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9" name="Tab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05431716"/>
              </p:ext>
            </p:extLst>
          </p:nvPr>
        </p:nvGraphicFramePr>
        <p:xfrm>
          <a:off x="6334635" y="1313832"/>
          <a:ext cx="4481411" cy="5485877"/>
        </p:xfrm>
        <a:graphic>
          <a:graphicData uri="http://schemas.openxmlformats.org/drawingml/2006/table">
            <a:tbl>
              <a:tblPr/>
              <a:tblGrid>
                <a:gridCol w="1489091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196928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897696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897696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4987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Lab ID</a:t>
                      </a:r>
                      <a:endParaRPr lang="en-US" sz="105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Exon</a:t>
                      </a:r>
                      <a:endParaRPr lang="en-US" sz="105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# of patients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Individual ID  LOVD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493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089/DBI-921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on 8-29 Deletion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269374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1"/>
                  </a:ext>
                </a:extLst>
              </a:tr>
              <a:tr h="2493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348/DBI-1128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xon 8-30 Deletion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0269375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2"/>
                  </a:ext>
                </a:extLst>
              </a:tr>
              <a:tr h="2493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296/B-358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xon 8-36 Deletion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0269536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23"/>
                  </a:ext>
                </a:extLst>
              </a:tr>
              <a:tr h="2493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682/B-811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xon 8-37 Deletion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3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0269537</a:t>
                      </a:r>
                    </a:p>
                  </a:txBody>
                  <a:tcPr marL="6144" marR="6144" marT="61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24"/>
                  </a:ext>
                </a:extLst>
              </a:tr>
              <a:tr h="2493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640/DBI-1345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xon 8-39 Deletion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0269376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5"/>
                  </a:ext>
                </a:extLst>
              </a:tr>
              <a:tr h="2493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2064/DBI-1646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xon 8-41 Deletion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0269377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6"/>
                  </a:ext>
                </a:extLst>
              </a:tr>
              <a:tr h="2493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2155/DBI-1711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xon 8-42 Deletion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3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0269378</a:t>
                      </a:r>
                    </a:p>
                  </a:txBody>
                  <a:tcPr marL="6144" marR="6144" marT="614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27"/>
                  </a:ext>
                </a:extLst>
              </a:tr>
              <a:tr h="2493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446/B-500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xon 10-47 Deletion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0269379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8"/>
                  </a:ext>
                </a:extLst>
              </a:tr>
              <a:tr h="2493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2181/DBI-1737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on 3-26 Deletion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0269380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9"/>
                  </a:ext>
                </a:extLst>
              </a:tr>
              <a:tr h="2493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229/DBI-1033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on 3-34 Deletion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0269381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30"/>
                  </a:ext>
                </a:extLst>
              </a:tr>
              <a:tr h="2493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162/B-167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on 3-41 Deletion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0269397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31"/>
                  </a:ext>
                </a:extLst>
              </a:tr>
              <a:tr h="2493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050/DBI-1640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on 3-10 Deletion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0269382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32"/>
                  </a:ext>
                </a:extLst>
              </a:tr>
              <a:tr h="2493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244/B-268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on 3-11 Deletion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3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269383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33"/>
                  </a:ext>
                </a:extLst>
              </a:tr>
              <a:tr h="2493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221/B-232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on 5-27 Deletion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269384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34"/>
                  </a:ext>
                </a:extLst>
              </a:tr>
              <a:tr h="2493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925/DBI-1548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on 5-29 Deletion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269385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35"/>
                  </a:ext>
                </a:extLst>
              </a:tr>
              <a:tr h="2493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2072/DBI-1650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on 5-44 Deletion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269386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36"/>
                  </a:ext>
                </a:extLst>
              </a:tr>
              <a:tr h="2493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700/DBI-1390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on 5-9 Deletion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269387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37"/>
                  </a:ext>
                </a:extLst>
              </a:tr>
              <a:tr h="2493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400/DBI-1171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xon 10-11 Deletion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0269388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38"/>
                  </a:ext>
                </a:extLst>
              </a:tr>
              <a:tr h="2493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364/DBI-1143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xon 53-57 Deletion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0269389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39"/>
                  </a:ext>
                </a:extLst>
              </a:tr>
              <a:tr h="2493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512/B-589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on 62-74 Deletion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269390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4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99179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Table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78829879"/>
              </p:ext>
            </p:extLst>
          </p:nvPr>
        </p:nvGraphicFramePr>
        <p:xfrm>
          <a:off x="322217" y="1422074"/>
          <a:ext cx="5617028" cy="4747157"/>
        </p:xfrm>
        <a:graphic>
          <a:graphicData uri="http://schemas.openxmlformats.org/drawingml/2006/table">
            <a:tbl>
              <a:tblPr/>
              <a:tblGrid>
                <a:gridCol w="1199407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883427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384663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149531">
                  <a:extLst>
                    <a:ext uri="{9D8B030D-6E8A-4147-A177-3AD203B41FA5}">
                      <a16:colId xmlns:a16="http://schemas.microsoft.com/office/drawing/2014/main" xmlns="" val="728780215"/>
                    </a:ext>
                  </a:extLst>
                </a:gridCol>
              </a:tblGrid>
              <a:tr h="4663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Lab I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Exon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# of patients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Individual ID  LOVD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6192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712/DBI-1399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on 11-43 Duplication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269391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6192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986/DBI-1593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on 19-42 Duplication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/>
                          <a:ea typeface="+mn-ea"/>
                          <a:cs typeface="+mn-cs"/>
                        </a:rPr>
                        <a:t>1</a:t>
                      </a:r>
                      <a:endParaRPr kumimoji="0" 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269392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4663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690/DBI-598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on 3-11 Duplication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/>
                          <a:ea typeface="+mn-ea"/>
                          <a:cs typeface="+mn-cs"/>
                        </a:rPr>
                        <a:t>1</a:t>
                      </a:r>
                      <a:endParaRPr kumimoji="0" 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269393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4663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341/DBI-1120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on 3-23 Duplication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/>
                          <a:ea typeface="+mn-ea"/>
                          <a:cs typeface="+mn-cs"/>
                        </a:rPr>
                        <a:t>1</a:t>
                      </a:r>
                      <a:endParaRPr kumimoji="0" 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269394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4663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438/DBI-1192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on 3-6 Duplication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/>
                          <a:ea typeface="+mn-ea"/>
                          <a:cs typeface="+mn-cs"/>
                        </a:rPr>
                        <a:t>1</a:t>
                      </a:r>
                      <a:endParaRPr kumimoji="0" 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269398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48800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193/B-199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on 61-64 Duplication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/>
                          <a:ea typeface="+mn-ea"/>
                          <a:cs typeface="+mn-cs"/>
                        </a:rPr>
                        <a:t>1</a:t>
                      </a:r>
                      <a:endParaRPr kumimoji="0" 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269399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6192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310/B-376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on 64-67 Duplication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/>
                          <a:ea typeface="+mn-ea"/>
                          <a:cs typeface="+mn-cs"/>
                        </a:rPr>
                        <a:t>1</a:t>
                      </a:r>
                      <a:endParaRPr kumimoji="0" 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269400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53626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621/B-740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on 64-72 Duplication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/>
                          <a:ea typeface="+mn-ea"/>
                          <a:cs typeface="+mn-cs"/>
                        </a:rPr>
                        <a:t>1</a:t>
                      </a:r>
                      <a:endParaRPr kumimoji="0" 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269401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</a:tbl>
          </a:graphicData>
        </a:graphic>
      </p:graphicFrame>
      <p:sp>
        <p:nvSpPr>
          <p:cNvPr id="11" name="TextBox 10"/>
          <p:cNvSpPr txBox="1"/>
          <p:nvPr/>
        </p:nvSpPr>
        <p:spPr>
          <a:xfrm>
            <a:off x="3796984" y="344352"/>
            <a:ext cx="39167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B Table: Sixteen Novel duplications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2" name="Table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03939467"/>
              </p:ext>
            </p:extLst>
          </p:nvPr>
        </p:nvGraphicFramePr>
        <p:xfrm>
          <a:off x="6448696" y="1422074"/>
          <a:ext cx="5212080" cy="4763379"/>
        </p:xfrm>
        <a:graphic>
          <a:graphicData uri="http://schemas.openxmlformats.org/drawingml/2006/table">
            <a:tbl>
              <a:tblPr/>
              <a:tblGrid>
                <a:gridCol w="1274223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620982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219596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097279">
                  <a:extLst>
                    <a:ext uri="{9D8B030D-6E8A-4147-A177-3AD203B41FA5}">
                      <a16:colId xmlns:a16="http://schemas.microsoft.com/office/drawing/2014/main" xmlns="" val="728780215"/>
                    </a:ext>
                  </a:extLst>
                </a:gridCol>
              </a:tblGrid>
              <a:tr h="531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Lab I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Exon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# of patients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Individual ID  LOVD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531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431/DBI-1188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on 8-12 Duplication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269402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531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292/B-348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on 8-16 Duplication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/>
                          <a:ea typeface="+mn-ea"/>
                          <a:cs typeface="+mn-cs"/>
                        </a:rPr>
                        <a:t>1</a:t>
                      </a:r>
                      <a:endParaRPr kumimoji="0" 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269403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531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741/DBI-650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on 8-9 Duplication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/>
                          <a:ea typeface="+mn-ea"/>
                          <a:cs typeface="+mn-cs"/>
                        </a:rPr>
                        <a:t>1</a:t>
                      </a:r>
                      <a:endParaRPr kumimoji="0" 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269404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531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115/B-127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on 8-44 Duplication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/>
                          <a:ea typeface="+mn-ea"/>
                          <a:cs typeface="+mn-cs"/>
                        </a:rPr>
                        <a:t>1</a:t>
                      </a:r>
                      <a:endParaRPr kumimoji="0" 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269405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50833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2036/DBI-1629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Exon 23-41 Duplication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/>
                          <a:ea typeface="+mn-ea"/>
                          <a:cs typeface="+mn-cs"/>
                        </a:rPr>
                        <a:t>1</a:t>
                      </a:r>
                      <a:endParaRPr kumimoji="0" 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269406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  <a:tr h="531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220/B-231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on 3-16 Duplication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/>
                          <a:ea typeface="+mn-ea"/>
                          <a:cs typeface="+mn-cs"/>
                        </a:rPr>
                        <a:t>1</a:t>
                      </a:r>
                      <a:endParaRPr kumimoji="0" 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269407</a:t>
                      </a:r>
                    </a:p>
                  </a:txBody>
                  <a:tcPr marL="7617" marR="7617" marT="76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4"/>
                  </a:ext>
                </a:extLst>
              </a:tr>
              <a:tr h="531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1902/DBI-1528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on 3-5  Duplication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Times New Roman"/>
                          <a:ea typeface="+mn-ea"/>
                          <a:cs typeface="+mn-cs"/>
                        </a:rPr>
                        <a:t>1</a:t>
                      </a:r>
                      <a:endParaRPr kumimoji="0" 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Times New Roman"/>
                        <a:ea typeface="+mn-ea"/>
                        <a:cs typeface="+mn-cs"/>
                      </a:endParaRP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269408</a:t>
                      </a:r>
                    </a:p>
                  </a:txBody>
                  <a:tcPr marL="7617" marR="7617" marT="761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5"/>
                  </a:ext>
                </a:extLst>
              </a:tr>
              <a:tr h="5318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2096/DBI-1669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Exon 3-25 Duplication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Times New Roman"/>
                        </a:rPr>
                        <a:t>00269416</a:t>
                      </a:r>
                    </a:p>
                  </a:txBody>
                  <a:tcPr marL="7617" marR="7617" marT="761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128055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93565542"/>
              </p:ext>
            </p:extLst>
          </p:nvPr>
        </p:nvGraphicFramePr>
        <p:xfrm>
          <a:off x="2061986" y="1315244"/>
          <a:ext cx="8010664" cy="5092101"/>
        </p:xfrm>
        <a:graphic>
          <a:graphicData uri="http://schemas.openxmlformats.org/drawingml/2006/table">
            <a:tbl>
              <a:tblPr/>
              <a:tblGrid>
                <a:gridCol w="1890122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2801389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708068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611085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</a:tblGrid>
              <a:tr h="40752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Lab ID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Exon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# of patients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i="0" u="none" strike="noStrike" dirty="0" smtClean="0">
                          <a:solidFill>
                            <a:srgbClr val="000000"/>
                          </a:solidFill>
                          <a:latin typeface="Times New Roman"/>
                        </a:rPr>
                        <a:t>Individual ID  LOVD</a:t>
                      </a:r>
                    </a:p>
                  </a:txBody>
                  <a:tcPr marL="6144" marR="6144" marT="614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6112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latin typeface="Times New Roman"/>
                        </a:rPr>
                        <a:t>0896/DBI-77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latin typeface="Times New Roman"/>
                        </a:rPr>
                        <a:t>Exon 17-42 &amp; 45-52 Duplication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Times New Roman"/>
                        </a:rPr>
                        <a:t>1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latin typeface="Times New Roman"/>
                        </a:rPr>
                        <a:t>00269409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6112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latin typeface="Times New Roman"/>
                        </a:rPr>
                        <a:t>0190/B-19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latin typeface="Times New Roman"/>
                        </a:rPr>
                        <a:t>Exon 3-9 &amp; 18-44 Duplication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Times New Roman"/>
                        </a:rPr>
                        <a:t>1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latin typeface="Times New Roman"/>
                        </a:rPr>
                        <a:t>0026941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6112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latin typeface="Times New Roman"/>
                        </a:rPr>
                        <a:t>0176/B-18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latin typeface="Times New Roman"/>
                        </a:rPr>
                        <a:t>Exon 45-48 &amp; 53-55 Duplication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Times New Roman"/>
                        </a:rPr>
                        <a:t>1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latin typeface="Times New Roman"/>
                        </a:rPr>
                        <a:t>0026941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56859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latin typeface="Times New Roman"/>
                        </a:rPr>
                        <a:t>1719/DBI-140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latin typeface="Times New Roman"/>
                        </a:rPr>
                        <a:t>Exon 48 &amp; 51-55 Duplication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Times New Roman"/>
                        </a:rPr>
                        <a:t>1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latin typeface="Times New Roman"/>
                        </a:rPr>
                        <a:t>0026941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56859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latin typeface="Times New Roman"/>
                        </a:rPr>
                        <a:t>0227/B-24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latin typeface="Times New Roman"/>
                        </a:rPr>
                        <a:t>Exon 52-62 &amp; 66-79 Duplication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Times New Roman"/>
                        </a:rPr>
                        <a:t>2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latin typeface="Times New Roman"/>
                        </a:rPr>
                        <a:t>0026941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46562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latin typeface="Times New Roman"/>
                        </a:rPr>
                        <a:t>0974/DBI-84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b="0" i="0" u="none" strike="noStrike" dirty="0">
                          <a:solidFill>
                            <a:schemeClr val="tx1"/>
                          </a:solidFill>
                          <a:latin typeface="Times New Roman"/>
                        </a:rPr>
                        <a:t>Exon 5 </a:t>
                      </a:r>
                      <a:r>
                        <a:rPr lang="fr-FR" sz="1200" b="0" i="0" u="none" strike="noStrike" dirty="0" err="1">
                          <a:solidFill>
                            <a:schemeClr val="tx1"/>
                          </a:solidFill>
                          <a:latin typeface="Times New Roman"/>
                        </a:rPr>
                        <a:t>Deletion</a:t>
                      </a:r>
                      <a:r>
                        <a:rPr lang="fr-FR" sz="1200" b="0" i="0" u="none" strike="noStrike" dirty="0">
                          <a:solidFill>
                            <a:schemeClr val="tx1"/>
                          </a:solidFill>
                          <a:latin typeface="Times New Roman"/>
                        </a:rPr>
                        <a:t> &amp; Exon 6 Duplication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Times New Roman"/>
                        </a:rPr>
                        <a:t>1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latin typeface="Times New Roman"/>
                        </a:rPr>
                        <a:t>0026941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6112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latin typeface="Times New Roman"/>
                        </a:rPr>
                        <a:t>0282/B-33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latin typeface="Times New Roman"/>
                        </a:rPr>
                        <a:t>Exon 45-50 &amp; 53-54 Deletion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Times New Roman"/>
                        </a:rPr>
                        <a:t>3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latin typeface="Times New Roman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latin typeface="Times New Roman"/>
                        </a:rPr>
                        <a:t>0026941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611286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72/DBI-360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on 3-10 &amp; 18-41 deletion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N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IN" sz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IN" sz="12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N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274240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786831512"/>
                  </a:ext>
                </a:extLst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3424871" y="693463"/>
            <a:ext cx="51030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C Table: Eight Novel non-contiguous mutations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09981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85</Words>
  <Application>Microsoft Office PowerPoint</Application>
  <PresentationFormat>Custom</PresentationFormat>
  <Paragraphs>283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dcrc</dc:creator>
  <cp:lastModifiedBy>Jayaseela</cp:lastModifiedBy>
  <cp:revision>5</cp:revision>
  <dcterms:created xsi:type="dcterms:W3CDTF">2020-01-14T07:41:46Z</dcterms:created>
  <dcterms:modified xsi:type="dcterms:W3CDTF">2020-06-13T06:58:34Z</dcterms:modified>
</cp:coreProperties>
</file>